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BABF93"/>
    <a:srgbClr val="8AC090"/>
    <a:srgbClr val="C98577"/>
    <a:srgbClr val="6D7DC4"/>
    <a:srgbClr val="05C1BF"/>
    <a:srgbClr val="B86CC3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08"/>
    <p:restoredTop sz="95707"/>
  </p:normalViewPr>
  <p:slideViewPr>
    <p:cSldViewPr snapToGrid="0">
      <p:cViewPr varScale="1">
        <p:scale>
          <a:sx n="93" d="100"/>
          <a:sy n="93" d="100"/>
        </p:scale>
        <p:origin x="784" y="20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782F013-0680-5DB2-A6FC-53E56FD1980B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083B8331-4934-3C3E-4CFE-8F4754311C61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GB"/>
              <a:t>Click to edit Master subtitle style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A524A18-F784-8D8A-883D-28C7A564B3D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F74BF5-DF75-E345-9F97-B679D41D3D7A}" type="datetimeFigureOut">
              <a:rPr lang="en-US" smtClean="0"/>
              <a:t>7/6/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ABB1A17-6B0D-ACC5-B937-9C15BFF58D9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0097308-18E3-8D32-E74D-B32B0077F60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3DA518-3F7D-714E-ABEF-0ACA28670DE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5940515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9EE3DA3-811E-B84F-2EB4-E405F44C2DC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00C7CC74-6A67-3506-0406-A5B044863A3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CD61D98-AFC8-7FD7-4B66-3451D0C64B1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F74BF5-DF75-E345-9F97-B679D41D3D7A}" type="datetimeFigureOut">
              <a:rPr lang="en-US" smtClean="0"/>
              <a:t>7/6/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21736BC-CCD6-AAFC-71C7-C6ACD3F7F21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93E1CD3-68A5-9399-14FC-9C443DBE92F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3DA518-3F7D-714E-ABEF-0ACA28670DE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7121180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8F8B862E-AD79-1005-638E-7CB288143EFD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3223A942-FECF-F142-6DA1-282AC0E4914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8606447-1B37-0F13-1028-E9A3B1C116F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F74BF5-DF75-E345-9F97-B679D41D3D7A}" type="datetimeFigureOut">
              <a:rPr lang="en-US" smtClean="0"/>
              <a:t>7/6/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7E72716-D282-F660-4982-E2D433DA7D9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20DD246-AB3B-263E-F0FE-5B9E11902BC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3DA518-3F7D-714E-ABEF-0ACA28670DE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8565295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19946EB-BDA4-66C8-8395-EE3BC7C80D1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E6114AC-D479-6C15-0392-1B0515FB3007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C4715AE-CF25-4916-5D29-307A2261AFB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F74BF5-DF75-E345-9F97-B679D41D3D7A}" type="datetimeFigureOut">
              <a:rPr lang="en-US" smtClean="0"/>
              <a:t>7/6/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1AD453C-9BD7-2479-A972-8407874B448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63E828F-2129-DC9A-90DE-80CD6FFEA88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3DA518-3F7D-714E-ABEF-0ACA28670DE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1525875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9DED9BC-7567-6F38-FDF5-FCAB981C286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D8747C5-A9C9-C7AB-7996-31024CAEA58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2CF5B1A-4C6F-F733-ADEA-AE5C396C6B0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F74BF5-DF75-E345-9F97-B679D41D3D7A}" type="datetimeFigureOut">
              <a:rPr lang="en-US" smtClean="0"/>
              <a:t>7/6/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0C647CE-2723-CD63-A738-AB540188D17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64BE605-3527-B1DE-7FEC-EF98F6E40BE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3DA518-3F7D-714E-ABEF-0ACA28670DE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2685993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7D7C050-0A38-CB93-57C4-ED9FF47E256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BB18B4E-BF52-8504-3711-3B99C83D614A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2ABCED1D-EC69-8015-C01E-65DEFED9A9D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44067C1-860F-FEA1-FE37-B416BDE64E5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F74BF5-DF75-E345-9F97-B679D41D3D7A}" type="datetimeFigureOut">
              <a:rPr lang="en-US" smtClean="0"/>
              <a:t>7/6/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E984B4F-C0B1-FED6-172C-262EEE42327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B20FAF4-4BDB-A329-6019-13AA6FD49A8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3DA518-3F7D-714E-ABEF-0ACA28670DE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8551730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BF00050-B19E-37E2-45F2-5AE707903D9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A7E6857-CD59-0E02-0277-064FB0F4E13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E6A0B108-A2A7-1D84-C3DA-8FACF349794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2D15FA97-C55C-6991-BE51-380886C6E050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635D3C71-747F-9B81-EDAF-34153E1C6A73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1C372D10-CDE6-BE51-F6C4-6345B1ECE5C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F74BF5-DF75-E345-9F97-B679D41D3D7A}" type="datetimeFigureOut">
              <a:rPr lang="en-US" smtClean="0"/>
              <a:t>7/6/23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EB0AD084-5F05-31FB-9C07-6CCC2D4CD17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703536DD-AD5B-4E60-4D17-5F252F55498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3DA518-3F7D-714E-ABEF-0ACA28670DE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7260022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E8DFFED-2609-68E6-08ED-7B97D9E1463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4E8F22F0-3F1D-D366-4D30-C24C86ADDBE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F74BF5-DF75-E345-9F97-B679D41D3D7A}" type="datetimeFigureOut">
              <a:rPr lang="en-US" smtClean="0"/>
              <a:t>7/6/23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B8D909B5-786B-951F-D003-C77DDFFB153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41C15446-97B6-4DAF-B954-C64BE073B3E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3DA518-3F7D-714E-ABEF-0ACA28670DE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0881023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0D910EDF-58F2-8430-3DAB-9C6D8F70480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F74BF5-DF75-E345-9F97-B679D41D3D7A}" type="datetimeFigureOut">
              <a:rPr lang="en-US" smtClean="0"/>
              <a:t>7/6/23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78820E7B-A88A-6DBF-BDBA-219C995EFBB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F5BDCCBF-255B-7C8B-46C7-B276884D560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3DA518-3F7D-714E-ABEF-0ACA28670DE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9482079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DCD29B2-7442-8286-122C-8AAEF5F432A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79256EB-B58F-23CE-0944-93E76701CA7A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D93B8513-86F9-8210-DF69-8E21C58CBEC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E20D4C2-4471-0E68-D56B-03AC87944FB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F74BF5-DF75-E345-9F97-B679D41D3D7A}" type="datetimeFigureOut">
              <a:rPr lang="en-US" smtClean="0"/>
              <a:t>7/6/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C9420FE-3E16-6723-04B9-A7D1A07C02D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86B552C-85D2-F475-BD60-3F28A5F5440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3DA518-3F7D-714E-ABEF-0ACA28670DE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4717874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7F02AC5-C63F-817F-1A5F-1D27034EF03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9CEA5889-C9D9-0333-5DFB-1F25E3E132DC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1259C434-4A7F-FA53-2181-1FC8CFFB0CB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CD77286-5AB6-19BD-A102-E1B3C66237F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F74BF5-DF75-E345-9F97-B679D41D3D7A}" type="datetimeFigureOut">
              <a:rPr lang="en-US" smtClean="0"/>
              <a:t>7/6/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1824AFD9-1F51-B0A6-0379-B3CAE07E922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10842FC-45F6-6D79-F750-16EF4E218FD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3DA518-3F7D-714E-ABEF-0ACA28670DE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6260964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C37E418D-57FC-FA5A-10FF-AA33C622983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6A36FCF-8D0D-2A97-487C-519D658443E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29EAF4E-0F92-631C-A65D-DC39CE876E43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7F74BF5-DF75-E345-9F97-B679D41D3D7A}" type="datetimeFigureOut">
              <a:rPr lang="en-US" smtClean="0"/>
              <a:t>7/6/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8B4467D-CA79-0B04-845E-DF5E0790CC7D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C188056-17BB-A775-A73B-5ACF885F1636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F3DA518-3F7D-714E-ABEF-0ACA28670DE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7633047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Oval 3">
            <a:extLst>
              <a:ext uri="{FF2B5EF4-FFF2-40B4-BE49-F238E27FC236}">
                <a16:creationId xmlns:a16="http://schemas.microsoft.com/office/drawing/2014/main" id="{2535A01C-5995-697A-5D19-3EEE6B9B86A7}"/>
              </a:ext>
            </a:extLst>
          </p:cNvPr>
          <p:cNvSpPr/>
          <p:nvPr/>
        </p:nvSpPr>
        <p:spPr>
          <a:xfrm>
            <a:off x="3654670" y="2058684"/>
            <a:ext cx="1729153" cy="756137"/>
          </a:xfrm>
          <a:prstGeom prst="ellipse">
            <a:avLst/>
          </a:prstGeom>
          <a:solidFill>
            <a:srgbClr val="8AC09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600" dirty="0"/>
              <a:t>Delivery should include</a:t>
            </a:r>
          </a:p>
        </p:txBody>
      </p:sp>
      <p:sp>
        <p:nvSpPr>
          <p:cNvPr id="6" name="Oval 5">
            <a:extLst>
              <a:ext uri="{FF2B5EF4-FFF2-40B4-BE49-F238E27FC236}">
                <a16:creationId xmlns:a16="http://schemas.microsoft.com/office/drawing/2014/main" id="{25C2FE66-3051-A769-3774-4DD340D2BFD0}"/>
              </a:ext>
            </a:extLst>
          </p:cNvPr>
          <p:cNvSpPr/>
          <p:nvPr/>
        </p:nvSpPr>
        <p:spPr>
          <a:xfrm>
            <a:off x="5383823" y="1572358"/>
            <a:ext cx="1729153" cy="756136"/>
          </a:xfrm>
          <a:prstGeom prst="ellipse">
            <a:avLst/>
          </a:prstGeom>
          <a:solidFill>
            <a:srgbClr val="BABF93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600" dirty="0"/>
              <a:t>Structure of sessions</a:t>
            </a:r>
          </a:p>
        </p:txBody>
      </p:sp>
      <p:sp>
        <p:nvSpPr>
          <p:cNvPr id="7" name="Oval 6">
            <a:extLst>
              <a:ext uri="{FF2B5EF4-FFF2-40B4-BE49-F238E27FC236}">
                <a16:creationId xmlns:a16="http://schemas.microsoft.com/office/drawing/2014/main" id="{E06D4E37-334E-CC7E-BB2B-413905931AB1}"/>
              </a:ext>
            </a:extLst>
          </p:cNvPr>
          <p:cNvSpPr/>
          <p:nvPr/>
        </p:nvSpPr>
        <p:spPr>
          <a:xfrm>
            <a:off x="7170177" y="2065095"/>
            <a:ext cx="1729153" cy="756136"/>
          </a:xfrm>
          <a:prstGeom prst="ellipse">
            <a:avLst/>
          </a:prstGeom>
          <a:solidFill>
            <a:srgbClr val="B86CC3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600" dirty="0"/>
              <a:t>Content should include</a:t>
            </a:r>
          </a:p>
        </p:txBody>
      </p:sp>
      <p:sp>
        <p:nvSpPr>
          <p:cNvPr id="8" name="Oval 7">
            <a:extLst>
              <a:ext uri="{FF2B5EF4-FFF2-40B4-BE49-F238E27FC236}">
                <a16:creationId xmlns:a16="http://schemas.microsoft.com/office/drawing/2014/main" id="{FD37A194-DB01-C9B2-4259-CBF8FA762804}"/>
              </a:ext>
            </a:extLst>
          </p:cNvPr>
          <p:cNvSpPr/>
          <p:nvPr/>
        </p:nvSpPr>
        <p:spPr>
          <a:xfrm>
            <a:off x="3654131" y="3310857"/>
            <a:ext cx="1729153" cy="756137"/>
          </a:xfrm>
          <a:prstGeom prst="ellipse">
            <a:avLst/>
          </a:prstGeom>
          <a:solidFill>
            <a:srgbClr val="C9857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600" dirty="0"/>
              <a:t>Content for Birth Partners</a:t>
            </a:r>
          </a:p>
        </p:txBody>
      </p:sp>
      <p:sp>
        <p:nvSpPr>
          <p:cNvPr id="9" name="Oval 8">
            <a:extLst>
              <a:ext uri="{FF2B5EF4-FFF2-40B4-BE49-F238E27FC236}">
                <a16:creationId xmlns:a16="http://schemas.microsoft.com/office/drawing/2014/main" id="{6C70C8C7-22C9-FE55-A963-6949146402A8}"/>
              </a:ext>
            </a:extLst>
          </p:cNvPr>
          <p:cNvSpPr/>
          <p:nvPr/>
        </p:nvSpPr>
        <p:spPr>
          <a:xfrm>
            <a:off x="5500208" y="3947742"/>
            <a:ext cx="1729154" cy="756139"/>
          </a:xfrm>
          <a:prstGeom prst="ellipse">
            <a:avLst/>
          </a:prstGeom>
          <a:solidFill>
            <a:srgbClr val="6D7DC4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600" dirty="0"/>
              <a:t>Supporting resources</a:t>
            </a:r>
          </a:p>
        </p:txBody>
      </p:sp>
      <p:sp>
        <p:nvSpPr>
          <p:cNvPr id="10" name="Oval 9">
            <a:extLst>
              <a:ext uri="{FF2B5EF4-FFF2-40B4-BE49-F238E27FC236}">
                <a16:creationId xmlns:a16="http://schemas.microsoft.com/office/drawing/2014/main" id="{578A3FEE-DF56-6098-2A7C-AC3CB23A07C5}"/>
              </a:ext>
            </a:extLst>
          </p:cNvPr>
          <p:cNvSpPr/>
          <p:nvPr/>
        </p:nvSpPr>
        <p:spPr>
          <a:xfrm>
            <a:off x="5246806" y="2638613"/>
            <a:ext cx="2247900" cy="970082"/>
          </a:xfrm>
          <a:prstGeom prst="ellipse">
            <a:avLst/>
          </a:prstGeom>
          <a:noFill/>
          <a:ln w="38100"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b="1" dirty="0">
                <a:solidFill>
                  <a:srgbClr val="0070C0"/>
                </a:solidFill>
              </a:rPr>
              <a:t>Amalgamated findings from focus groups</a:t>
            </a:r>
          </a:p>
        </p:txBody>
      </p:sp>
      <p:sp>
        <p:nvSpPr>
          <p:cNvPr id="11" name="Oval 10">
            <a:extLst>
              <a:ext uri="{FF2B5EF4-FFF2-40B4-BE49-F238E27FC236}">
                <a16:creationId xmlns:a16="http://schemas.microsoft.com/office/drawing/2014/main" id="{510002FD-A3CE-9A5B-CFC4-EDB2395B15CF}"/>
              </a:ext>
            </a:extLst>
          </p:cNvPr>
          <p:cNvSpPr/>
          <p:nvPr/>
        </p:nvSpPr>
        <p:spPr>
          <a:xfrm>
            <a:off x="7170177" y="3400149"/>
            <a:ext cx="1729154" cy="756139"/>
          </a:xfrm>
          <a:prstGeom prst="ellipse">
            <a:avLst/>
          </a:prstGeom>
          <a:solidFill>
            <a:srgbClr val="05C1BF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600" dirty="0"/>
              <a:t>Developing Social Support</a:t>
            </a:r>
          </a:p>
        </p:txBody>
      </p:sp>
      <p:sp>
        <p:nvSpPr>
          <p:cNvPr id="12" name="Oval 11">
            <a:extLst>
              <a:ext uri="{FF2B5EF4-FFF2-40B4-BE49-F238E27FC236}">
                <a16:creationId xmlns:a16="http://schemas.microsoft.com/office/drawing/2014/main" id="{6BC5932E-9756-2370-F5EB-38757EF49ECF}"/>
              </a:ext>
            </a:extLst>
          </p:cNvPr>
          <p:cNvSpPr/>
          <p:nvPr/>
        </p:nvSpPr>
        <p:spPr>
          <a:xfrm>
            <a:off x="4132385" y="17583"/>
            <a:ext cx="4232030" cy="1480038"/>
          </a:xfrm>
          <a:prstGeom prst="ellipse">
            <a:avLst/>
          </a:prstGeom>
          <a:solidFill>
            <a:srgbClr val="BABF93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600" dirty="0"/>
              <a:t>Need enough sessions</a:t>
            </a:r>
          </a:p>
          <a:p>
            <a:pPr algn="ctr"/>
            <a:r>
              <a:rPr lang="en-US" sz="1600" dirty="0"/>
              <a:t>Timing weekday vs weekend</a:t>
            </a:r>
          </a:p>
          <a:p>
            <a:pPr algn="ctr"/>
            <a:r>
              <a:rPr lang="en-US" sz="1600" dirty="0"/>
              <a:t>How to book/hear about</a:t>
            </a:r>
          </a:p>
          <a:p>
            <a:pPr algn="ctr"/>
            <a:r>
              <a:rPr lang="en-US" sz="1600" dirty="0"/>
              <a:t>Need a dedicated team to deliver</a:t>
            </a:r>
          </a:p>
          <a:p>
            <a:pPr algn="ctr"/>
            <a:r>
              <a:rPr lang="en-US" sz="1600" dirty="0"/>
              <a:t>Group sizes</a:t>
            </a:r>
          </a:p>
        </p:txBody>
      </p:sp>
      <p:sp>
        <p:nvSpPr>
          <p:cNvPr id="13" name="Oval 12">
            <a:extLst>
              <a:ext uri="{FF2B5EF4-FFF2-40B4-BE49-F238E27FC236}">
                <a16:creationId xmlns:a16="http://schemas.microsoft.com/office/drawing/2014/main" id="{09844605-E076-17E4-EA9D-FEF4FFDFFB18}"/>
              </a:ext>
            </a:extLst>
          </p:cNvPr>
          <p:cNvSpPr/>
          <p:nvPr/>
        </p:nvSpPr>
        <p:spPr>
          <a:xfrm>
            <a:off x="8725451" y="146953"/>
            <a:ext cx="3118338" cy="2963737"/>
          </a:xfrm>
          <a:prstGeom prst="ellipse">
            <a:avLst/>
          </a:prstGeom>
          <a:solidFill>
            <a:srgbClr val="B86CC3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600" dirty="0"/>
              <a:t>Physiology of </a:t>
            </a:r>
            <a:r>
              <a:rPr lang="en-US" sz="1600" dirty="0" err="1"/>
              <a:t>labour</a:t>
            </a:r>
            <a:endParaRPr lang="en-US" sz="1600" dirty="0"/>
          </a:p>
          <a:p>
            <a:pPr algn="ctr"/>
            <a:r>
              <a:rPr lang="en-US" sz="1600" dirty="0"/>
              <a:t>Interventions (Induction, cesarean, instrumental)</a:t>
            </a:r>
          </a:p>
          <a:p>
            <a:pPr algn="ctr"/>
            <a:r>
              <a:rPr lang="en-US" sz="1600" dirty="0"/>
              <a:t>Third stage &amp; Tears</a:t>
            </a:r>
          </a:p>
          <a:p>
            <a:pPr algn="ctr"/>
            <a:r>
              <a:rPr lang="en-US" sz="1600" dirty="0"/>
              <a:t>Rationale for decision making</a:t>
            </a:r>
          </a:p>
          <a:p>
            <a:pPr algn="ctr"/>
            <a:r>
              <a:rPr lang="en-US" sz="1600" dirty="0"/>
              <a:t>Place of birth</a:t>
            </a:r>
          </a:p>
          <a:p>
            <a:pPr algn="ctr"/>
            <a:r>
              <a:rPr lang="en-US" sz="1600" dirty="0"/>
              <a:t>Pain relief/strategies</a:t>
            </a:r>
          </a:p>
          <a:p>
            <a:pPr algn="ctr"/>
            <a:r>
              <a:rPr lang="en-US" sz="1600" dirty="0"/>
              <a:t>Statistics</a:t>
            </a:r>
          </a:p>
        </p:txBody>
      </p:sp>
      <p:sp>
        <p:nvSpPr>
          <p:cNvPr id="14" name="Oval 13">
            <a:extLst>
              <a:ext uri="{FF2B5EF4-FFF2-40B4-BE49-F238E27FC236}">
                <a16:creationId xmlns:a16="http://schemas.microsoft.com/office/drawing/2014/main" id="{8E8A23C2-55FA-9935-6E1B-A2A07231EB0F}"/>
              </a:ext>
            </a:extLst>
          </p:cNvPr>
          <p:cNvSpPr/>
          <p:nvPr/>
        </p:nvSpPr>
        <p:spPr>
          <a:xfrm>
            <a:off x="338701" y="17583"/>
            <a:ext cx="3364523" cy="3528650"/>
          </a:xfrm>
          <a:prstGeom prst="ellipse">
            <a:avLst/>
          </a:prstGeom>
          <a:solidFill>
            <a:srgbClr val="8AC09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600" dirty="0"/>
              <a:t>Good quality information</a:t>
            </a:r>
          </a:p>
          <a:p>
            <a:pPr algn="ctr"/>
            <a:r>
              <a:rPr lang="en-US" sz="1600" dirty="0"/>
              <a:t>Variety of activities</a:t>
            </a:r>
          </a:p>
          <a:p>
            <a:pPr algn="ctr"/>
            <a:r>
              <a:rPr lang="en-US" sz="1600" dirty="0"/>
              <a:t>Don’t want to have to draw/ask questions out loud</a:t>
            </a:r>
          </a:p>
          <a:p>
            <a:pPr algn="ctr"/>
            <a:r>
              <a:rPr lang="en-US" sz="1600" dirty="0"/>
              <a:t>Happy to touch on topics rather than go in depth</a:t>
            </a:r>
          </a:p>
          <a:p>
            <a:pPr algn="ctr"/>
            <a:r>
              <a:rPr lang="en-US" sz="1600" dirty="0"/>
              <a:t>Not too rushed</a:t>
            </a:r>
          </a:p>
          <a:p>
            <a:pPr algn="ctr"/>
            <a:r>
              <a:rPr lang="en-US" sz="1600" dirty="0"/>
              <a:t>Skills rehearsal</a:t>
            </a:r>
          </a:p>
          <a:p>
            <a:pPr algn="ctr"/>
            <a:r>
              <a:rPr lang="en-US" sz="1600" dirty="0"/>
              <a:t>Need to include partners</a:t>
            </a:r>
          </a:p>
          <a:p>
            <a:pPr algn="ctr"/>
            <a:r>
              <a:rPr lang="en-US" sz="1600" dirty="0"/>
              <a:t>Want timelines </a:t>
            </a:r>
          </a:p>
        </p:txBody>
      </p:sp>
      <p:sp>
        <p:nvSpPr>
          <p:cNvPr id="15" name="Oval 14">
            <a:extLst>
              <a:ext uri="{FF2B5EF4-FFF2-40B4-BE49-F238E27FC236}">
                <a16:creationId xmlns:a16="http://schemas.microsoft.com/office/drawing/2014/main" id="{24D79C3F-DE0F-AF0D-3DDA-DEC4F1CB8129}"/>
              </a:ext>
            </a:extLst>
          </p:cNvPr>
          <p:cNvSpPr/>
          <p:nvPr/>
        </p:nvSpPr>
        <p:spPr>
          <a:xfrm>
            <a:off x="3930872" y="4856654"/>
            <a:ext cx="4867826" cy="1970939"/>
          </a:xfrm>
          <a:prstGeom prst="ellipse">
            <a:avLst/>
          </a:prstGeom>
          <a:solidFill>
            <a:srgbClr val="6D7DC4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600" dirty="0"/>
              <a:t>Want good quality resources</a:t>
            </a:r>
          </a:p>
          <a:p>
            <a:pPr algn="ctr"/>
            <a:r>
              <a:rPr lang="en-US" sz="1600" dirty="0"/>
              <a:t>Like weblinks</a:t>
            </a:r>
          </a:p>
          <a:p>
            <a:pPr algn="ctr"/>
            <a:r>
              <a:rPr lang="en-US" sz="1600" dirty="0"/>
              <a:t>Like videos and dynamic decision trees</a:t>
            </a:r>
          </a:p>
          <a:p>
            <a:pPr algn="ctr"/>
            <a:r>
              <a:rPr lang="en-US" sz="1600" dirty="0"/>
              <a:t>Like to know who people are if something happens</a:t>
            </a:r>
          </a:p>
          <a:p>
            <a:pPr algn="ctr"/>
            <a:r>
              <a:rPr lang="en-US" sz="1600" dirty="0"/>
              <a:t>Apps good</a:t>
            </a:r>
          </a:p>
          <a:p>
            <a:pPr algn="ctr"/>
            <a:r>
              <a:rPr lang="en-US" sz="1600" dirty="0"/>
              <a:t>Birth preferences</a:t>
            </a:r>
          </a:p>
        </p:txBody>
      </p:sp>
      <p:sp>
        <p:nvSpPr>
          <p:cNvPr id="16" name="Oval 15">
            <a:extLst>
              <a:ext uri="{FF2B5EF4-FFF2-40B4-BE49-F238E27FC236}">
                <a16:creationId xmlns:a16="http://schemas.microsoft.com/office/drawing/2014/main" id="{B2F5A68A-0C10-88F5-6674-A9B3899BF6E6}"/>
              </a:ext>
            </a:extLst>
          </p:cNvPr>
          <p:cNvSpPr/>
          <p:nvPr/>
        </p:nvSpPr>
        <p:spPr>
          <a:xfrm>
            <a:off x="8631799" y="3310857"/>
            <a:ext cx="3118338" cy="2963737"/>
          </a:xfrm>
          <a:prstGeom prst="ellipse">
            <a:avLst/>
          </a:prstGeom>
          <a:solidFill>
            <a:srgbClr val="05C1BF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600" dirty="0"/>
              <a:t>Like WhatsApp group</a:t>
            </a:r>
          </a:p>
          <a:p>
            <a:pPr algn="ctr"/>
            <a:r>
              <a:rPr lang="en-US" sz="1600" dirty="0"/>
              <a:t>Signposting to Facebook groups/ local mums groups</a:t>
            </a:r>
          </a:p>
          <a:p>
            <a:pPr algn="ctr"/>
            <a:r>
              <a:rPr lang="en-US" sz="1600" dirty="0"/>
              <a:t>Avoiding loneliness</a:t>
            </a:r>
          </a:p>
          <a:p>
            <a:pPr algn="ctr"/>
            <a:r>
              <a:rPr lang="en-US" sz="1600" dirty="0"/>
              <a:t>Would like a follow up session</a:t>
            </a:r>
          </a:p>
          <a:p>
            <a:pPr algn="ctr"/>
            <a:r>
              <a:rPr lang="en-US" sz="1600" dirty="0"/>
              <a:t>Would like an opportunity to </a:t>
            </a:r>
            <a:r>
              <a:rPr lang="en-US" sz="1600" dirty="0" err="1"/>
              <a:t>socialise</a:t>
            </a:r>
            <a:r>
              <a:rPr lang="en-US" sz="1600" dirty="0"/>
              <a:t> in the session</a:t>
            </a:r>
          </a:p>
        </p:txBody>
      </p:sp>
      <p:sp>
        <p:nvSpPr>
          <p:cNvPr id="18" name="Oval 17">
            <a:extLst>
              <a:ext uri="{FF2B5EF4-FFF2-40B4-BE49-F238E27FC236}">
                <a16:creationId xmlns:a16="http://schemas.microsoft.com/office/drawing/2014/main" id="{FF27B75C-1704-B04B-2900-ECF491A00BD7}"/>
              </a:ext>
            </a:extLst>
          </p:cNvPr>
          <p:cNvSpPr/>
          <p:nvPr/>
        </p:nvSpPr>
        <p:spPr>
          <a:xfrm>
            <a:off x="1034134" y="3522103"/>
            <a:ext cx="3118338" cy="2509012"/>
          </a:xfrm>
          <a:prstGeom prst="ellipse">
            <a:avLst/>
          </a:prstGeom>
          <a:solidFill>
            <a:srgbClr val="C9857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600" dirty="0"/>
              <a:t>How to support women</a:t>
            </a:r>
          </a:p>
          <a:p>
            <a:pPr algn="ctr"/>
            <a:r>
              <a:rPr lang="en-US" sz="1600" dirty="0"/>
              <a:t>How they can advocate for their partner</a:t>
            </a:r>
          </a:p>
          <a:p>
            <a:pPr algn="ctr"/>
            <a:r>
              <a:rPr lang="en-US" sz="1600" dirty="0"/>
              <a:t>Tips practical/emotional </a:t>
            </a:r>
          </a:p>
          <a:p>
            <a:pPr algn="ctr"/>
            <a:r>
              <a:rPr lang="en-US" sz="1600" dirty="0"/>
              <a:t>Emotional support for fathers</a:t>
            </a:r>
          </a:p>
        </p:txBody>
      </p:sp>
    </p:spTree>
    <p:extLst>
      <p:ext uri="{BB962C8B-B14F-4D97-AF65-F5344CB8AC3E}">
        <p14:creationId xmlns:p14="http://schemas.microsoft.com/office/powerpoint/2010/main" val="199957624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0</TotalTime>
  <Words>181</Words>
  <Application>Microsoft Macintosh PowerPoint</Application>
  <PresentationFormat>Widescreen</PresentationFormat>
  <Paragraphs>42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erriel, Abi</dc:creator>
  <cp:lastModifiedBy>Abi Merriel</cp:lastModifiedBy>
  <cp:revision>5</cp:revision>
  <dcterms:created xsi:type="dcterms:W3CDTF">2022-10-15T10:59:16Z</dcterms:created>
  <dcterms:modified xsi:type="dcterms:W3CDTF">2023-07-06T09:33:18Z</dcterms:modified>
</cp:coreProperties>
</file>